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2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B5C48-F46A-D795-C9D4-57699AA17C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E96E93-6CB2-EA68-1DB7-5E90ECC0B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3537BC-3659-E3AD-E082-1CF8E421F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2545EB-F83D-4D62-34E8-B3D6B2644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20F5A-B4BA-8AB8-623A-C598462D4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0244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570EB5-0B2F-0B69-480E-272BD803B4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47482-2A3E-5948-F141-AFDAE783D2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37A51-4F7E-16F8-1F83-826B3149F2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292817-8BD7-6790-20C0-9CDB63EE4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1EB4C-11F0-10B7-5E7C-B525B4BCE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08550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06A7BC0-BFFA-4E10-1CEA-F97A0E3BDA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23E8D9-EA98-FB61-9616-12CDC6098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44EC3D-9938-2026-DA0D-186B7FCF9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BFBACE-D551-0D34-840E-0972D59F9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3BEC0-EBB0-D9EC-97D4-4DE3925FA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6562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2304D9-787C-E9CE-785E-C71ED8E6B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D12EDB-E404-D1DC-991E-B0D79C0238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9D5D9B-212B-8DE1-F967-1787BA0C1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E06481-71B7-DF3A-BBE6-A14615620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72417B-9D11-7AAB-3B40-D6582460D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2545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38389-6F18-C6C8-AF71-F6DF94C07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666CE3-0456-9093-1C04-06413D49C0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08BA5C-DBAD-3F20-9366-5B88D223D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D0F3A3-9429-1F27-44CC-4B50332D8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7A5C4-1E41-ADC3-1786-53FDD2F50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4709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9BD9B8-BC7B-7C10-1E75-FD3740E37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83ABC8-E60E-DD47-E0A2-439AC963E1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602D96-9838-8088-4DE0-3E819CBFC9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8C5876-A0C5-DBE4-905A-9DD0C63E4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4824A6-D179-506F-E6A4-67C49DE39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B87EB5-1F3E-E57B-F05B-3155BEBB4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77678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82365C-B8DB-EC84-60BB-C3CEEE73E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D4F24E-3947-70B9-4C0C-016D05CDC1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FF1D97-E7D7-AB49-5412-66FE9538CB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A15085-0D32-F9A6-0A17-CF2D0CA2CF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BA1453-5D7B-F0C1-089F-F72A9A4CA9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D97C12-734A-A540-5B8E-F9E2370B5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D470AE-A806-414B-D45C-661E8A2F9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ACC07EB-5B6B-7F0F-854E-9B77846AB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03533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20966-7B2D-A2B1-1BD8-CE49FD064A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CE4D41-647F-43BB-475F-1480A5690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E3EE17-BB00-5B67-1401-2FB772CBA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36B573-C5C6-8372-ACB5-45535DECF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95760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5310D9-CD82-E217-1EB3-66C88A324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A505C7-64D6-1599-A39B-87EF294B5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277004-BA0D-F3FC-0CD5-BC563ECB2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86082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FD200-1E22-7982-B1C7-946D8D7475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BDB11F-4414-63F9-FDA1-F4AC015665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13FA96-E3B0-3084-FB4D-CD504BB8D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6EAFD9-2977-B947-B480-4BFD760A7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CED164-17BC-4557-5FFD-70166E5F8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E93E76-63CA-937D-C526-713FF14E2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38873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94BE3-3294-2198-B2FA-DA871D7E11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6079D5-EE36-209F-2EEA-BD4B87331B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CF604E-69A3-4BE8-D590-147C025DFF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BDA02B-F2B4-DBC0-5AB0-EFBDAA8EB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95C40D-F678-88B6-7CE7-994B56F61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02B633-CDDC-E8AD-B3D1-5C8157462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65492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A714601-8E12-2023-34A4-D2F5A73EE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6615E7-5DEE-608F-65D6-B6100C33A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DD8B61-A0D2-3438-79B6-32D37D2A85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F6BD6A-8FB9-494F-A4BB-79F7E0C25075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C9646-5487-85AF-4074-C993E9C408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D82E89-C302-2B94-156F-2426ABDB21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8A942D-6A33-41CD-B949-CF69FABE11D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88139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0031C70-62EA-3A82-5FCF-EB8530F3AEDA}"/>
              </a:ext>
            </a:extLst>
          </p:cNvPr>
          <p:cNvSpPr txBox="1"/>
          <p:nvPr/>
        </p:nvSpPr>
        <p:spPr>
          <a:xfrm>
            <a:off x="439464" y="5106953"/>
            <a:ext cx="955587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l-NL" sz="1800" b="1" dirty="0"/>
              <a:t>Supplemental </a:t>
            </a:r>
            <a:r>
              <a:rPr lang="nl-NL" sz="1800" b="1" dirty="0" err="1"/>
              <a:t>figure</a:t>
            </a:r>
            <a:r>
              <a:rPr lang="nl-NL" sz="1800" b="1" dirty="0"/>
              <a:t> 1</a:t>
            </a:r>
          </a:p>
          <a:p>
            <a:r>
              <a:rPr lang="nl-NL" sz="1800" dirty="0" err="1"/>
              <a:t>Principal</a:t>
            </a:r>
            <a:r>
              <a:rPr lang="nl-NL" sz="1800" dirty="0"/>
              <a:t> component analysis. The </a:t>
            </a:r>
            <a:r>
              <a:rPr lang="nl-NL" sz="1800" dirty="0" err="1"/>
              <a:t>average</a:t>
            </a:r>
            <a:r>
              <a:rPr lang="nl-NL" sz="1800" dirty="0"/>
              <a:t> change in micro-RNA-</a:t>
            </a:r>
            <a:r>
              <a:rPr lang="nl-NL" sz="1800" dirty="0" err="1"/>
              <a:t>expression</a:t>
            </a:r>
            <a:r>
              <a:rPr lang="nl-NL" sz="1800" dirty="0"/>
              <a:t> </a:t>
            </a:r>
            <a:r>
              <a:rPr lang="nl-NL" sz="1800" dirty="0" err="1"/>
              <a:t>after</a:t>
            </a:r>
            <a:r>
              <a:rPr lang="nl-NL" sz="1800" dirty="0"/>
              <a:t> </a:t>
            </a:r>
            <a:r>
              <a:rPr lang="nl-NL" sz="1800" dirty="0" err="1"/>
              <a:t>conversion</a:t>
            </a:r>
            <a:r>
              <a:rPr lang="nl-NL" sz="1800" dirty="0"/>
              <a:t> </a:t>
            </a:r>
            <a:r>
              <a:rPr lang="nl-NL" sz="1800" dirty="0" err="1"/>
              <a:t>to</a:t>
            </a:r>
            <a:r>
              <a:rPr lang="nl-NL" sz="1800" dirty="0"/>
              <a:t> belatacept (blue </a:t>
            </a:r>
            <a:r>
              <a:rPr lang="nl-NL" sz="1800" dirty="0" err="1"/>
              <a:t>centroid</a:t>
            </a:r>
            <a:r>
              <a:rPr lang="nl-NL" sz="1800" dirty="0"/>
              <a:t>) does </a:t>
            </a:r>
            <a:r>
              <a:rPr lang="nl-NL" sz="1800" dirty="0" err="1"/>
              <a:t>not</a:t>
            </a:r>
            <a:r>
              <a:rPr lang="nl-NL" sz="1800" dirty="0"/>
              <a:t> </a:t>
            </a:r>
            <a:r>
              <a:rPr lang="nl-NL" sz="1800" dirty="0" err="1"/>
              <a:t>differ</a:t>
            </a:r>
            <a:r>
              <a:rPr lang="nl-NL" sz="1800" dirty="0"/>
              <a:t> </a:t>
            </a:r>
            <a:r>
              <a:rPr lang="nl-NL" sz="1800" dirty="0" err="1"/>
              <a:t>from</a:t>
            </a:r>
            <a:r>
              <a:rPr lang="nl-NL" sz="1800" dirty="0"/>
              <a:t> </a:t>
            </a:r>
            <a:r>
              <a:rPr lang="nl-NL" sz="1800" dirty="0" err="1"/>
              <a:t>controls</a:t>
            </a:r>
            <a:r>
              <a:rPr lang="nl-NL" sz="1800" dirty="0"/>
              <a:t> (red </a:t>
            </a:r>
            <a:r>
              <a:rPr lang="nl-NL" sz="1800" dirty="0" err="1"/>
              <a:t>centroid</a:t>
            </a:r>
            <a:r>
              <a:rPr lang="nl-NL" sz="1800" dirty="0"/>
              <a:t>). </a:t>
            </a:r>
          </a:p>
        </p:txBody>
      </p:sp>
      <p:pic>
        <p:nvPicPr>
          <p:cNvPr id="6" name="Picture 5" descr="A diagram of a circle with red and blue dots">
            <a:extLst>
              <a:ext uri="{FF2B5EF4-FFF2-40B4-BE49-F238E27FC236}">
                <a16:creationId xmlns:a16="http://schemas.microsoft.com/office/drawing/2014/main" id="{F7E0FECE-07CD-7A44-95A9-F0606189DA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841" y="100637"/>
            <a:ext cx="6484560" cy="50063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9179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edewold, O.W. (INT)</dc:creator>
  <cp:lastModifiedBy>Bredewold, Edwin (INT - LUMC)</cp:lastModifiedBy>
  <cp:revision>1</cp:revision>
  <dcterms:created xsi:type="dcterms:W3CDTF">2025-12-01T11:31:49Z</dcterms:created>
  <dcterms:modified xsi:type="dcterms:W3CDTF">2026-04-03T08:25:15Z</dcterms:modified>
</cp:coreProperties>
</file>